
<file path=[Content_Types].xml><?xml version="1.0" encoding="utf-8"?>
<Types xmlns="http://schemas.openxmlformats.org/package/2006/content-types"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6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  <p:sldId id="270" r:id="rId3"/>
    <p:sldId id="269" r:id="rId4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5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34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tksh0\Desktop\&#12467;&#12500;&#12540;mCRPC%20ENZ%20CTC%20database.v2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C:\Users\tksh0\Desktop\&#12467;&#12500;&#12540;mCRPC%20ENZ%20CTC%20database.v2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file:///C:\Users\tksh0\Desktop\&#12467;&#12500;&#12540;mCRPC%20ENZ%20CTC%20database.v2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oleObject" Target="file:///C:\Users\tksh0\Desktop\&#12467;&#12500;&#12540;mCRPC%20ENZ%20CTC%20database.v2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oleObject" Target="file:///C:\Users\tksh0\Downloads\&#12467;&#12500;&#12540;mCRPC%20ENZ%20CTC%20database.v2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6.xm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400" dirty="0">
                <a:solidFill>
                  <a:schemeClr val="tx1"/>
                </a:solidFill>
              </a:rPr>
              <a:t>BSI change in patients</a:t>
            </a:r>
            <a:r>
              <a:rPr lang="en-US" altLang="ja-JP" sz="1400" baseline="0" dirty="0">
                <a:solidFill>
                  <a:schemeClr val="tx1"/>
                </a:solidFill>
              </a:rPr>
              <a:t> with </a:t>
            </a:r>
            <a:br>
              <a:rPr lang="en-US" altLang="ja-JP" sz="1400" baseline="0" dirty="0">
                <a:solidFill>
                  <a:schemeClr val="tx1"/>
                </a:solidFill>
              </a:rPr>
            </a:br>
            <a:r>
              <a:rPr lang="en-US" altLang="ja-JP" sz="1400" dirty="0">
                <a:solidFill>
                  <a:schemeClr val="tx1"/>
                </a:solidFill>
              </a:rPr>
              <a:t>visceral metastasi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upple Figure1'!$J$1</c:f>
              <c:strCache>
                <c:ptCount val="1"/>
                <c:pt idx="0">
                  <c:v>BSI change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24A2-4278-B907-E8157C822D3C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24A2-4278-B907-E8157C822D3C}"/>
              </c:ext>
            </c:extLst>
          </c:dPt>
          <c:dPt>
            <c:idx val="2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24A2-4278-B907-E8157C822D3C}"/>
              </c:ext>
            </c:extLst>
          </c:dPt>
          <c:dPt>
            <c:idx val="3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24A2-4278-B907-E8157C822D3C}"/>
              </c:ext>
            </c:extLst>
          </c:dPt>
          <c:dPt>
            <c:idx val="4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24A2-4278-B907-E8157C822D3C}"/>
              </c:ext>
            </c:extLst>
          </c:dPt>
          <c:dPt>
            <c:idx val="5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24A2-4278-B907-E8157C822D3C}"/>
              </c:ext>
            </c:extLst>
          </c:dPt>
          <c:dPt>
            <c:idx val="6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24A2-4278-B907-E8157C822D3C}"/>
              </c:ext>
            </c:extLst>
          </c:dPt>
          <c:dPt>
            <c:idx val="7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24A2-4278-B907-E8157C822D3C}"/>
              </c:ext>
            </c:extLst>
          </c:dPt>
          <c:dPt>
            <c:idx val="8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24A2-4278-B907-E8157C822D3C}"/>
              </c:ext>
            </c:extLst>
          </c:dPt>
          <c:dPt>
            <c:idx val="9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24A2-4278-B907-E8157C822D3C}"/>
              </c:ext>
            </c:extLst>
          </c:dPt>
          <c:dPt>
            <c:idx val="1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5-24A2-4278-B907-E8157C822D3C}"/>
              </c:ext>
            </c:extLst>
          </c:dPt>
          <c:dPt>
            <c:idx val="11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7-24A2-4278-B907-E8157C822D3C}"/>
              </c:ext>
            </c:extLst>
          </c:dPt>
          <c:dPt>
            <c:idx val="12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9-24A2-4278-B907-E8157C822D3C}"/>
              </c:ext>
            </c:extLst>
          </c:dPt>
          <c:dPt>
            <c:idx val="13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B-24A2-4278-B907-E8157C822D3C}"/>
              </c:ext>
            </c:extLst>
          </c:dPt>
          <c:dPt>
            <c:idx val="14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D-24A2-4278-B907-E8157C822D3C}"/>
              </c:ext>
            </c:extLst>
          </c:dPt>
          <c:dPt>
            <c:idx val="15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F-24A2-4278-B907-E8157C822D3C}"/>
              </c:ext>
            </c:extLst>
          </c:dPt>
          <c:dPt>
            <c:idx val="16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1-24A2-4278-B907-E8157C822D3C}"/>
              </c:ext>
            </c:extLst>
          </c:dPt>
          <c:dPt>
            <c:idx val="17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3-24A2-4278-B907-E8157C822D3C}"/>
              </c:ext>
            </c:extLst>
          </c:dPt>
          <c:dPt>
            <c:idx val="18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5-24A2-4278-B907-E8157C822D3C}"/>
              </c:ext>
            </c:extLst>
          </c:dPt>
          <c:val>
            <c:numRef>
              <c:f>'supple Figure1'!$J$2:$J$16</c:f>
              <c:numCache>
                <c:formatCode>0.0%</c:formatCode>
                <c:ptCount val="15"/>
                <c:pt idx="0">
                  <c:v>0.22676579925650553</c:v>
                </c:pt>
                <c:pt idx="1">
                  <c:v>4.4628626075868594E-2</c:v>
                </c:pt>
                <c:pt idx="2">
                  <c:v>0</c:v>
                </c:pt>
                <c:pt idx="3">
                  <c:v>-0.54838709677419351</c:v>
                </c:pt>
                <c:pt idx="4">
                  <c:v>-0.55957767722473606</c:v>
                </c:pt>
                <c:pt idx="5">
                  <c:v>-0.83333333333333326</c:v>
                </c:pt>
                <c:pt idx="6">
                  <c:v>-0.89830508474576276</c:v>
                </c:pt>
                <c:pt idx="7">
                  <c:v>-0.93103448275862066</c:v>
                </c:pt>
                <c:pt idx="8">
                  <c:v>-1</c:v>
                </c:pt>
                <c:pt idx="9">
                  <c:v>-1</c:v>
                </c:pt>
                <c:pt idx="10">
                  <c:v>-1</c:v>
                </c:pt>
                <c:pt idx="11">
                  <c:v>-1</c:v>
                </c:pt>
                <c:pt idx="12">
                  <c:v>-1</c:v>
                </c:pt>
                <c:pt idx="13">
                  <c:v>-1</c:v>
                </c:pt>
                <c:pt idx="14">
                  <c:v>-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6-24A2-4278-B907-E8157C822D3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6408768"/>
        <c:axId val="346411120"/>
      </c:barChart>
      <c:catAx>
        <c:axId val="346408768"/>
        <c:scaling>
          <c:orientation val="minMax"/>
        </c:scaling>
        <c:delete val="0"/>
        <c:axPos val="b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46411120"/>
        <c:crosses val="autoZero"/>
        <c:auto val="1"/>
        <c:lblAlgn val="ctr"/>
        <c:lblOffset val="100"/>
        <c:noMultiLvlLbl val="0"/>
      </c:catAx>
      <c:valAx>
        <c:axId val="346411120"/>
        <c:scaling>
          <c:orientation val="minMax"/>
          <c:max val="1"/>
          <c:min val="-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46408768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400" dirty="0">
                <a:solidFill>
                  <a:schemeClr val="tx1"/>
                </a:solidFill>
              </a:rPr>
              <a:t>PSA change </a:t>
            </a:r>
            <a:r>
              <a:rPr lang="en-US" altLang="ja-JP" sz="1400" b="0" i="0" u="none" strike="noStrike" kern="1200" spc="0" baseline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 patients with </a:t>
            </a:r>
            <a:br>
              <a:rPr lang="en-US" altLang="ja-JP" sz="1400" b="0" i="0" u="none" strike="noStrike" kern="1200" spc="0" baseline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ja-JP" sz="1400" dirty="0">
                <a:solidFill>
                  <a:schemeClr val="tx1"/>
                </a:solidFill>
              </a:rPr>
              <a:t>visceral metastasi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upple Figure1'!$M$22</c:f>
              <c:strCache>
                <c:ptCount val="1"/>
                <c:pt idx="0">
                  <c:v>PSA change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9AAE-4F25-A83D-40CEEF3CD79A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9AAE-4F25-A83D-40CEEF3CD79A}"/>
              </c:ext>
            </c:extLst>
          </c:dPt>
          <c:dPt>
            <c:idx val="2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9AAE-4F25-A83D-40CEEF3CD79A}"/>
              </c:ext>
            </c:extLst>
          </c:dPt>
          <c:dPt>
            <c:idx val="3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9AAE-4F25-A83D-40CEEF3CD79A}"/>
              </c:ext>
            </c:extLst>
          </c:dPt>
          <c:dPt>
            <c:idx val="4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9AAE-4F25-A83D-40CEEF3CD79A}"/>
              </c:ext>
            </c:extLst>
          </c:dPt>
          <c:dPt>
            <c:idx val="5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9AAE-4F25-A83D-40CEEF3CD79A}"/>
              </c:ext>
            </c:extLst>
          </c:dPt>
          <c:dPt>
            <c:idx val="6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9AAE-4F25-A83D-40CEEF3CD79A}"/>
              </c:ext>
            </c:extLst>
          </c:dPt>
          <c:dPt>
            <c:idx val="7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9AAE-4F25-A83D-40CEEF3CD79A}"/>
              </c:ext>
            </c:extLst>
          </c:dPt>
          <c:dPt>
            <c:idx val="8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9AAE-4F25-A83D-40CEEF3CD79A}"/>
              </c:ext>
            </c:extLst>
          </c:dPt>
          <c:dPt>
            <c:idx val="9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9AAE-4F25-A83D-40CEEF3CD79A}"/>
              </c:ext>
            </c:extLst>
          </c:dPt>
          <c:dPt>
            <c:idx val="1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5-9AAE-4F25-A83D-40CEEF3CD79A}"/>
              </c:ext>
            </c:extLst>
          </c:dPt>
          <c:dPt>
            <c:idx val="11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7-9AAE-4F25-A83D-40CEEF3CD79A}"/>
              </c:ext>
            </c:extLst>
          </c:dPt>
          <c:dPt>
            <c:idx val="12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9-9AAE-4F25-A83D-40CEEF3CD79A}"/>
              </c:ext>
            </c:extLst>
          </c:dPt>
          <c:dPt>
            <c:idx val="13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B-9AAE-4F25-A83D-40CEEF3CD79A}"/>
              </c:ext>
            </c:extLst>
          </c:dPt>
          <c:dPt>
            <c:idx val="14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D-9AAE-4F25-A83D-40CEEF3CD79A}"/>
              </c:ext>
            </c:extLst>
          </c:dPt>
          <c:dPt>
            <c:idx val="15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F-9AAE-4F25-A83D-40CEEF3CD79A}"/>
              </c:ext>
            </c:extLst>
          </c:dPt>
          <c:dPt>
            <c:idx val="16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1-9AAE-4F25-A83D-40CEEF3CD79A}"/>
              </c:ext>
            </c:extLst>
          </c:dPt>
          <c:dPt>
            <c:idx val="17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3-9AAE-4F25-A83D-40CEEF3CD79A}"/>
              </c:ext>
            </c:extLst>
          </c:dPt>
          <c:dPt>
            <c:idx val="18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5-9AAE-4F25-A83D-40CEEF3CD79A}"/>
              </c:ext>
            </c:extLst>
          </c:dPt>
          <c:val>
            <c:numRef>
              <c:f>'supple Figure1'!$M$23:$M$37</c:f>
              <c:numCache>
                <c:formatCode>0%</c:formatCode>
                <c:ptCount val="15"/>
                <c:pt idx="0">
                  <c:v>1</c:v>
                </c:pt>
                <c:pt idx="1">
                  <c:v>1</c:v>
                </c:pt>
                <c:pt idx="2">
                  <c:v>-0.59268854346574562</c:v>
                </c:pt>
                <c:pt idx="3">
                  <c:v>-0.59805653710247353</c:v>
                </c:pt>
                <c:pt idx="4">
                  <c:v>-0.61771844660194175</c:v>
                </c:pt>
                <c:pt idx="5">
                  <c:v>-0.71729913817069779</c:v>
                </c:pt>
                <c:pt idx="6">
                  <c:v>-0.80547112462006076</c:v>
                </c:pt>
                <c:pt idx="7">
                  <c:v>-0.84067278287461777</c:v>
                </c:pt>
                <c:pt idx="8">
                  <c:v>-0.88316073840612341</c:v>
                </c:pt>
                <c:pt idx="9">
                  <c:v>-0.88517857142857137</c:v>
                </c:pt>
                <c:pt idx="10">
                  <c:v>-0.9316638370118846</c:v>
                </c:pt>
                <c:pt idx="11">
                  <c:v>-0.95805851063829783</c:v>
                </c:pt>
                <c:pt idx="12">
                  <c:v>-0.98901098901098905</c:v>
                </c:pt>
                <c:pt idx="13">
                  <c:v>-0.995</c:v>
                </c:pt>
                <c:pt idx="14">
                  <c:v>-0.998054474708171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6-9AAE-4F25-A83D-40CEEF3CD79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6408768"/>
        <c:axId val="346411120"/>
      </c:barChart>
      <c:catAx>
        <c:axId val="346408768"/>
        <c:scaling>
          <c:orientation val="minMax"/>
        </c:scaling>
        <c:delete val="0"/>
        <c:axPos val="b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46411120"/>
        <c:crosses val="autoZero"/>
        <c:auto val="1"/>
        <c:lblAlgn val="ctr"/>
        <c:lblOffset val="100"/>
        <c:noMultiLvlLbl val="0"/>
      </c:catAx>
      <c:valAx>
        <c:axId val="346411120"/>
        <c:scaling>
          <c:orientation val="minMax"/>
          <c:max val="1"/>
          <c:min val="-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464087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6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dirty="0">
                <a:solidFill>
                  <a:schemeClr val="tx1"/>
                </a:solidFill>
              </a:rPr>
              <a:t>BSI change in patients</a:t>
            </a:r>
            <a:r>
              <a:rPr lang="en-US" altLang="ja-JP" baseline="0" dirty="0">
                <a:solidFill>
                  <a:schemeClr val="tx1"/>
                </a:solidFill>
              </a:rPr>
              <a:t> </a:t>
            </a:r>
            <a:br>
              <a:rPr lang="en-US" altLang="ja-JP" baseline="0" dirty="0">
                <a:solidFill>
                  <a:schemeClr val="tx1"/>
                </a:solidFill>
              </a:rPr>
            </a:br>
            <a:r>
              <a:rPr lang="en-US" altLang="ja-JP" baseline="0" dirty="0">
                <a:solidFill>
                  <a:schemeClr val="tx1"/>
                </a:solidFill>
              </a:rPr>
              <a:t>pre-treated with </a:t>
            </a:r>
            <a:r>
              <a:rPr lang="en-US" altLang="ja-JP" dirty="0">
                <a:solidFill>
                  <a:schemeClr val="tx1"/>
                </a:solidFill>
              </a:rPr>
              <a:t>docetaxel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6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upple Figure2'!$H$1</c:f>
              <c:strCache>
                <c:ptCount val="1"/>
                <c:pt idx="0">
                  <c:v>BSI change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0190-4FD1-A344-C5A99F41A523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0190-4FD1-A344-C5A99F41A523}"/>
              </c:ext>
            </c:extLst>
          </c:dPt>
          <c:dPt>
            <c:idx val="2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0190-4FD1-A344-C5A99F41A523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0190-4FD1-A344-C5A99F41A523}"/>
              </c:ext>
            </c:extLst>
          </c:dPt>
          <c:dPt>
            <c:idx val="4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0190-4FD1-A344-C5A99F41A523}"/>
              </c:ext>
            </c:extLst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0190-4FD1-A344-C5A99F41A523}"/>
              </c:ext>
            </c:extLst>
          </c:dPt>
          <c:dPt>
            <c:idx val="6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0190-4FD1-A344-C5A99F41A523}"/>
              </c:ext>
            </c:extLst>
          </c:dPt>
          <c:dPt>
            <c:idx val="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0190-4FD1-A344-C5A99F41A523}"/>
              </c:ext>
            </c:extLst>
          </c:dPt>
          <c:dPt>
            <c:idx val="8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0190-4FD1-A344-C5A99F41A523}"/>
              </c:ext>
            </c:extLst>
          </c:dPt>
          <c:dPt>
            <c:idx val="9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0190-4FD1-A344-C5A99F41A523}"/>
              </c:ext>
            </c:extLst>
          </c:dPt>
          <c:dPt>
            <c:idx val="1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5-0190-4FD1-A344-C5A99F41A523}"/>
              </c:ext>
            </c:extLst>
          </c:dPt>
          <c:dPt>
            <c:idx val="11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7-0190-4FD1-A344-C5A99F41A523}"/>
              </c:ext>
            </c:extLst>
          </c:dPt>
          <c:dPt>
            <c:idx val="12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9-0190-4FD1-A344-C5A99F41A523}"/>
              </c:ext>
            </c:extLst>
          </c:dPt>
          <c:dPt>
            <c:idx val="13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B-0190-4FD1-A344-C5A99F41A523}"/>
              </c:ext>
            </c:extLst>
          </c:dPt>
          <c:dPt>
            <c:idx val="14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D-0190-4FD1-A344-C5A99F41A523}"/>
              </c:ext>
            </c:extLst>
          </c:dPt>
          <c:dPt>
            <c:idx val="15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F-0190-4FD1-A344-C5A99F41A523}"/>
              </c:ext>
            </c:extLst>
          </c:dPt>
          <c:dPt>
            <c:idx val="16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1-0190-4FD1-A344-C5A99F41A523}"/>
              </c:ext>
            </c:extLst>
          </c:dPt>
          <c:dPt>
            <c:idx val="17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3-0190-4FD1-A344-C5A99F41A523}"/>
              </c:ext>
            </c:extLst>
          </c:dPt>
          <c:dPt>
            <c:idx val="18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5-0190-4FD1-A344-C5A99F41A523}"/>
              </c:ext>
            </c:extLst>
          </c:dPt>
          <c:val>
            <c:numRef>
              <c:f>'supple Figure2'!$H$2:$H$22</c:f>
              <c:numCache>
                <c:formatCode>0%</c:formatCode>
                <c:ptCount val="21"/>
                <c:pt idx="0">
                  <c:v>1</c:v>
                </c:pt>
                <c:pt idx="1">
                  <c:v>1</c:v>
                </c:pt>
                <c:pt idx="2">
                  <c:v>0.88311688311688297</c:v>
                </c:pt>
                <c:pt idx="3">
                  <c:v>0.22413793103448287</c:v>
                </c:pt>
                <c:pt idx="4">
                  <c:v>0.16666666666666674</c:v>
                </c:pt>
                <c:pt idx="5">
                  <c:v>0.125</c:v>
                </c:pt>
                <c:pt idx="6">
                  <c:v>4.4628626075868594E-2</c:v>
                </c:pt>
                <c:pt idx="7">
                  <c:v>0</c:v>
                </c:pt>
                <c:pt idx="8">
                  <c:v>-5.5555555555555469E-2</c:v>
                </c:pt>
                <c:pt idx="9">
                  <c:v>-7.3232323232323204E-2</c:v>
                </c:pt>
                <c:pt idx="10">
                  <c:v>-0.27927927927927931</c:v>
                </c:pt>
                <c:pt idx="11">
                  <c:v>-0.36</c:v>
                </c:pt>
                <c:pt idx="12">
                  <c:v>-0.42727272727272736</c:v>
                </c:pt>
                <c:pt idx="13">
                  <c:v>-0.55957767722473606</c:v>
                </c:pt>
                <c:pt idx="14">
                  <c:v>-0.83333333333333326</c:v>
                </c:pt>
                <c:pt idx="15">
                  <c:v>-0.8666666666666667</c:v>
                </c:pt>
                <c:pt idx="16">
                  <c:v>-1</c:v>
                </c:pt>
                <c:pt idx="17">
                  <c:v>-1</c:v>
                </c:pt>
                <c:pt idx="18">
                  <c:v>-1</c:v>
                </c:pt>
                <c:pt idx="19">
                  <c:v>-1</c:v>
                </c:pt>
                <c:pt idx="20">
                  <c:v>-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6-0190-4FD1-A344-C5A99F41A52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6408768"/>
        <c:axId val="346411120"/>
      </c:barChart>
      <c:catAx>
        <c:axId val="346408768"/>
        <c:scaling>
          <c:orientation val="minMax"/>
        </c:scaling>
        <c:delete val="0"/>
        <c:axPos val="b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46411120"/>
        <c:crosses val="autoZero"/>
        <c:auto val="1"/>
        <c:lblAlgn val="ctr"/>
        <c:lblOffset val="100"/>
        <c:noMultiLvlLbl val="0"/>
      </c:catAx>
      <c:valAx>
        <c:axId val="346411120"/>
        <c:scaling>
          <c:orientation val="minMax"/>
          <c:max val="1"/>
          <c:min val="-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464087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6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dirty="0">
                <a:solidFill>
                  <a:schemeClr val="tx1"/>
                </a:solidFill>
              </a:rPr>
              <a:t>PSA change </a:t>
            </a:r>
            <a:r>
              <a:rPr lang="en-US" altLang="ja-JP" sz="1600" b="0" i="0" u="none" strike="noStrike" baseline="0" dirty="0">
                <a:solidFill>
                  <a:schemeClr val="tx1"/>
                </a:solidFill>
                <a:effectLst/>
              </a:rPr>
              <a:t>in patients </a:t>
            </a:r>
            <a:br>
              <a:rPr lang="en-US" altLang="ja-JP" sz="1600" b="0" i="0" u="none" strike="noStrike" baseline="0" dirty="0">
                <a:solidFill>
                  <a:schemeClr val="tx1"/>
                </a:solidFill>
                <a:effectLst/>
              </a:rPr>
            </a:br>
            <a:r>
              <a:rPr lang="en-US" altLang="ja-JP" sz="1600" b="0" i="0" u="none" strike="noStrike" baseline="0" dirty="0">
                <a:solidFill>
                  <a:schemeClr val="tx1"/>
                </a:solidFill>
                <a:effectLst/>
              </a:rPr>
              <a:t>pre-treated with docetaxel</a:t>
            </a:r>
            <a:endParaRPr lang="en-US" altLang="ja-JP" dirty="0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6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upple Figure2'!$N$23</c:f>
              <c:strCache>
                <c:ptCount val="1"/>
                <c:pt idx="0">
                  <c:v>PSA change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B9F9-4971-B54F-5BFB08C5481D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B9F9-4971-B54F-5BFB08C5481D}"/>
              </c:ext>
            </c:extLst>
          </c:dPt>
          <c:dPt>
            <c:idx val="2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B9F9-4971-B54F-5BFB08C5481D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B9F9-4971-B54F-5BFB08C5481D}"/>
              </c:ext>
            </c:extLst>
          </c:dPt>
          <c:dPt>
            <c:idx val="4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B9F9-4971-B54F-5BFB08C5481D}"/>
              </c:ext>
            </c:extLst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B9F9-4971-B54F-5BFB08C5481D}"/>
              </c:ext>
            </c:extLst>
          </c:dPt>
          <c:dPt>
            <c:idx val="6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B9F9-4971-B54F-5BFB08C5481D}"/>
              </c:ext>
            </c:extLst>
          </c:dPt>
          <c:dPt>
            <c:idx val="7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B9F9-4971-B54F-5BFB08C5481D}"/>
              </c:ext>
            </c:extLst>
          </c:dPt>
          <c:dPt>
            <c:idx val="8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B9F9-4971-B54F-5BFB08C5481D}"/>
              </c:ext>
            </c:extLst>
          </c:dPt>
          <c:dPt>
            <c:idx val="9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B9F9-4971-B54F-5BFB08C5481D}"/>
              </c:ext>
            </c:extLst>
          </c:dPt>
          <c:dPt>
            <c:idx val="1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5-B9F9-4971-B54F-5BFB08C5481D}"/>
              </c:ext>
            </c:extLst>
          </c:dPt>
          <c:dPt>
            <c:idx val="11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7-B9F9-4971-B54F-5BFB08C5481D}"/>
              </c:ext>
            </c:extLst>
          </c:dPt>
          <c:dPt>
            <c:idx val="12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9-B9F9-4971-B54F-5BFB08C5481D}"/>
              </c:ext>
            </c:extLst>
          </c:dPt>
          <c:dPt>
            <c:idx val="13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B-B9F9-4971-B54F-5BFB08C5481D}"/>
              </c:ext>
            </c:extLst>
          </c:dPt>
          <c:dPt>
            <c:idx val="14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D-B9F9-4971-B54F-5BFB08C5481D}"/>
              </c:ext>
            </c:extLst>
          </c:dPt>
          <c:dPt>
            <c:idx val="15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F-B9F9-4971-B54F-5BFB08C5481D}"/>
              </c:ext>
            </c:extLst>
          </c:dPt>
          <c:dPt>
            <c:idx val="16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1-B9F9-4971-B54F-5BFB08C5481D}"/>
              </c:ext>
            </c:extLst>
          </c:dPt>
          <c:dPt>
            <c:idx val="17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3-B9F9-4971-B54F-5BFB08C5481D}"/>
              </c:ext>
            </c:extLst>
          </c:dPt>
          <c:dPt>
            <c:idx val="18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5-B9F9-4971-B54F-5BFB08C5481D}"/>
              </c:ext>
            </c:extLst>
          </c:dPt>
          <c:val>
            <c:numRef>
              <c:f>'supple Figure2'!$N$24:$N$44</c:f>
              <c:numCache>
                <c:formatCode>0%</c:formatCode>
                <c:ptCount val="21"/>
                <c:pt idx="0">
                  <c:v>1</c:v>
                </c:pt>
                <c:pt idx="1">
                  <c:v>1</c:v>
                </c:pt>
                <c:pt idx="2">
                  <c:v>0.79090909090909078</c:v>
                </c:pt>
                <c:pt idx="3">
                  <c:v>0.72950819672131151</c:v>
                </c:pt>
                <c:pt idx="4">
                  <c:v>0.52489244007375535</c:v>
                </c:pt>
                <c:pt idx="5">
                  <c:v>8.9018302828618889E-2</c:v>
                </c:pt>
                <c:pt idx="6">
                  <c:v>-0.59261796042617965</c:v>
                </c:pt>
                <c:pt idx="7">
                  <c:v>-0.59805653710247353</c:v>
                </c:pt>
                <c:pt idx="8">
                  <c:v>-0.68333333333333335</c:v>
                </c:pt>
                <c:pt idx="9">
                  <c:v>-0.71729913817069779</c:v>
                </c:pt>
                <c:pt idx="10">
                  <c:v>-0.72760646108663729</c:v>
                </c:pt>
                <c:pt idx="11">
                  <c:v>-0.80547112462006076</c:v>
                </c:pt>
                <c:pt idx="12">
                  <c:v>-0.86309523809523814</c:v>
                </c:pt>
                <c:pt idx="13">
                  <c:v>-0.88316073840612341</c:v>
                </c:pt>
                <c:pt idx="14">
                  <c:v>-0.93632075471698117</c:v>
                </c:pt>
                <c:pt idx="15">
                  <c:v>-0.95805851063829783</c:v>
                </c:pt>
                <c:pt idx="16">
                  <c:v>-0.96556886227544914</c:v>
                </c:pt>
                <c:pt idx="17">
                  <c:v>-0.96676205150781425</c:v>
                </c:pt>
                <c:pt idx="18">
                  <c:v>-0.97222222222222221</c:v>
                </c:pt>
                <c:pt idx="19">
                  <c:v>-0.97526416906820368</c:v>
                </c:pt>
                <c:pt idx="20">
                  <c:v>-0.989010989010989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6-B9F9-4971-B54F-5BFB08C5481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6408768"/>
        <c:axId val="346411120"/>
      </c:barChart>
      <c:catAx>
        <c:axId val="346408768"/>
        <c:scaling>
          <c:orientation val="minMax"/>
        </c:scaling>
        <c:delete val="0"/>
        <c:axPos val="b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46411120"/>
        <c:crosses val="autoZero"/>
        <c:auto val="1"/>
        <c:lblAlgn val="ctr"/>
        <c:lblOffset val="100"/>
        <c:noMultiLvlLbl val="0"/>
      </c:catAx>
      <c:valAx>
        <c:axId val="346411120"/>
        <c:scaling>
          <c:orientation val="minMax"/>
          <c:max val="1"/>
          <c:min val="-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464087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6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dirty="0">
                <a:solidFill>
                  <a:schemeClr val="tx1"/>
                </a:solidFill>
              </a:rPr>
              <a:t>BSI</a:t>
            </a:r>
            <a:r>
              <a:rPr lang="en-US" altLang="ja-JP" baseline="0" dirty="0">
                <a:solidFill>
                  <a:schemeClr val="tx1"/>
                </a:solidFill>
              </a:rPr>
              <a:t> change rate with BMA us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6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8CC1-46EA-9395-D7C79806B84A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8CC1-46EA-9395-D7C79806B84A}"/>
              </c:ext>
            </c:extLst>
          </c:dPt>
          <c:dPt>
            <c:idx val="2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8CC1-46EA-9395-D7C79806B84A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8CC1-46EA-9395-D7C79806B84A}"/>
              </c:ext>
            </c:extLst>
          </c:dPt>
          <c:dPt>
            <c:idx val="4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8CC1-46EA-9395-D7C79806B84A}"/>
              </c:ext>
            </c:extLst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8CC1-46EA-9395-D7C79806B84A}"/>
              </c:ext>
            </c:extLst>
          </c:dPt>
          <c:dPt>
            <c:idx val="6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8CC1-46EA-9395-D7C79806B84A}"/>
              </c:ext>
            </c:extLst>
          </c:dPt>
          <c:dPt>
            <c:idx val="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8CC1-46EA-9395-D7C79806B84A}"/>
              </c:ext>
            </c:extLst>
          </c:dPt>
          <c:dPt>
            <c:idx val="8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8CC1-46EA-9395-D7C79806B84A}"/>
              </c:ext>
            </c:extLst>
          </c:dPt>
          <c:dPt>
            <c:idx val="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8CC1-46EA-9395-D7C79806B84A}"/>
              </c:ext>
            </c:extLst>
          </c:dPt>
          <c:dPt>
            <c:idx val="1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5-8CC1-46EA-9395-D7C79806B84A}"/>
              </c:ext>
            </c:extLst>
          </c:dPt>
          <c:dPt>
            <c:idx val="1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7-8CC1-46EA-9395-D7C79806B84A}"/>
              </c:ext>
            </c:extLst>
          </c:dPt>
          <c:dPt>
            <c:idx val="12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9-8CC1-46EA-9395-D7C79806B84A}"/>
              </c:ext>
            </c:extLst>
          </c:dPt>
          <c:dPt>
            <c:idx val="1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B-8CC1-46EA-9395-D7C79806B84A}"/>
              </c:ext>
            </c:extLst>
          </c:dPt>
          <c:dPt>
            <c:idx val="14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D-8CC1-46EA-9395-D7C79806B84A}"/>
              </c:ext>
            </c:extLst>
          </c:dPt>
          <c:dPt>
            <c:idx val="1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F-8CC1-46EA-9395-D7C79806B84A}"/>
              </c:ext>
            </c:extLst>
          </c:dPt>
          <c:dPt>
            <c:idx val="16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1-8CC1-46EA-9395-D7C79806B84A}"/>
              </c:ext>
            </c:extLst>
          </c:dPt>
          <c:dPt>
            <c:idx val="1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3-8CC1-46EA-9395-D7C79806B84A}"/>
              </c:ext>
            </c:extLst>
          </c:dPt>
          <c:dPt>
            <c:idx val="18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5-8CC1-46EA-9395-D7C79806B84A}"/>
              </c:ext>
            </c:extLst>
          </c:dPt>
          <c:val>
            <c:numRef>
              <c:f>'supple Figure3 ++'!$E$2:$E$70</c:f>
              <c:numCache>
                <c:formatCode>0.0%</c:formatCode>
                <c:ptCount val="69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0.88311688311688297</c:v>
                </c:pt>
                <c:pt idx="7">
                  <c:v>0.8085106382978724</c:v>
                </c:pt>
                <c:pt idx="8">
                  <c:v>0.5625</c:v>
                </c:pt>
                <c:pt idx="9">
                  <c:v>0.24242424242424221</c:v>
                </c:pt>
                <c:pt idx="10">
                  <c:v>0.22676579925650553</c:v>
                </c:pt>
                <c:pt idx="11">
                  <c:v>0.22413793103448287</c:v>
                </c:pt>
                <c:pt idx="12">
                  <c:v>0.16666666666666674</c:v>
                </c:pt>
                <c:pt idx="13">
                  <c:v>0.125</c:v>
                </c:pt>
                <c:pt idx="14">
                  <c:v>0.11111111111111116</c:v>
                </c:pt>
                <c:pt idx="15">
                  <c:v>4.4776119402984982E-2</c:v>
                </c:pt>
                <c:pt idx="16">
                  <c:v>4.4628626075868594E-2</c:v>
                </c:pt>
                <c:pt idx="17">
                  <c:v>2.9585798816567976E-2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-2.8985507246376718E-2</c:v>
                </c:pt>
                <c:pt idx="23">
                  <c:v>-4.7755491881566359E-2</c:v>
                </c:pt>
                <c:pt idx="24">
                  <c:v>-4.9255441008018264E-2</c:v>
                </c:pt>
                <c:pt idx="25">
                  <c:v>-5.5555555555555469E-2</c:v>
                </c:pt>
                <c:pt idx="26">
                  <c:v>-7.3232323232323204E-2</c:v>
                </c:pt>
                <c:pt idx="27">
                  <c:v>-0.12727272727272743</c:v>
                </c:pt>
                <c:pt idx="28">
                  <c:v>-0.16513761467889909</c:v>
                </c:pt>
                <c:pt idx="29">
                  <c:v>-0.18717277486910988</c:v>
                </c:pt>
                <c:pt idx="30">
                  <c:v>-0.1875</c:v>
                </c:pt>
                <c:pt idx="31">
                  <c:v>-0.20000000000000007</c:v>
                </c:pt>
                <c:pt idx="32">
                  <c:v>-0.25</c:v>
                </c:pt>
                <c:pt idx="33">
                  <c:v>-0.26666666666666672</c:v>
                </c:pt>
                <c:pt idx="34">
                  <c:v>-0.27927927927927931</c:v>
                </c:pt>
                <c:pt idx="35">
                  <c:v>-0.31818181818181823</c:v>
                </c:pt>
                <c:pt idx="36">
                  <c:v>-0.33333333333333326</c:v>
                </c:pt>
                <c:pt idx="37">
                  <c:v>-0.42727272727272736</c:v>
                </c:pt>
                <c:pt idx="38">
                  <c:v>-0.55957767722473606</c:v>
                </c:pt>
                <c:pt idx="39">
                  <c:v>-0.63902053712480256</c:v>
                </c:pt>
                <c:pt idx="40">
                  <c:v>-0.69565217391304346</c:v>
                </c:pt>
                <c:pt idx="41">
                  <c:v>-0.8666666666666667</c:v>
                </c:pt>
                <c:pt idx="42">
                  <c:v>-0.89830508474576276</c:v>
                </c:pt>
                <c:pt idx="43">
                  <c:v>-0.90322580645161288</c:v>
                </c:pt>
                <c:pt idx="44">
                  <c:v>-0.93103448275862066</c:v>
                </c:pt>
                <c:pt idx="45">
                  <c:v>-0.93548387096774199</c:v>
                </c:pt>
                <c:pt idx="46">
                  <c:v>-0.98701298701298701</c:v>
                </c:pt>
                <c:pt idx="47">
                  <c:v>-1</c:v>
                </c:pt>
                <c:pt idx="48">
                  <c:v>-1</c:v>
                </c:pt>
                <c:pt idx="49">
                  <c:v>-1</c:v>
                </c:pt>
                <c:pt idx="50">
                  <c:v>-1</c:v>
                </c:pt>
                <c:pt idx="51">
                  <c:v>-1</c:v>
                </c:pt>
                <c:pt idx="52">
                  <c:v>-1</c:v>
                </c:pt>
                <c:pt idx="53">
                  <c:v>-1</c:v>
                </c:pt>
                <c:pt idx="54">
                  <c:v>-1</c:v>
                </c:pt>
                <c:pt idx="55">
                  <c:v>-1</c:v>
                </c:pt>
                <c:pt idx="56">
                  <c:v>-1</c:v>
                </c:pt>
                <c:pt idx="57">
                  <c:v>-1</c:v>
                </c:pt>
                <c:pt idx="58">
                  <c:v>-1</c:v>
                </c:pt>
                <c:pt idx="59">
                  <c:v>-1</c:v>
                </c:pt>
                <c:pt idx="60">
                  <c:v>-1</c:v>
                </c:pt>
                <c:pt idx="61">
                  <c:v>-1</c:v>
                </c:pt>
                <c:pt idx="62">
                  <c:v>-1</c:v>
                </c:pt>
                <c:pt idx="63">
                  <c:v>-1</c:v>
                </c:pt>
                <c:pt idx="64">
                  <c:v>-1</c:v>
                </c:pt>
                <c:pt idx="65">
                  <c:v>-1</c:v>
                </c:pt>
                <c:pt idx="66">
                  <c:v>-1</c:v>
                </c:pt>
                <c:pt idx="67">
                  <c:v>-1</c:v>
                </c:pt>
                <c:pt idx="68">
                  <c:v>-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6-8CC1-46EA-9395-D7C79806B8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6408768"/>
        <c:axId val="346411120"/>
      </c:barChart>
      <c:catAx>
        <c:axId val="346408768"/>
        <c:scaling>
          <c:orientation val="minMax"/>
        </c:scaling>
        <c:delete val="0"/>
        <c:axPos val="b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46411120"/>
        <c:crosses val="autoZero"/>
        <c:auto val="1"/>
        <c:lblAlgn val="ctr"/>
        <c:lblOffset val="100"/>
        <c:noMultiLvlLbl val="0"/>
      </c:catAx>
      <c:valAx>
        <c:axId val="346411120"/>
        <c:scaling>
          <c:orientation val="minMax"/>
          <c:max val="1"/>
          <c:min val="-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464087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6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dirty="0">
                <a:solidFill>
                  <a:schemeClr val="tx1"/>
                </a:solidFill>
              </a:rPr>
              <a:t>BSI change without</a:t>
            </a:r>
            <a:r>
              <a:rPr lang="en-US" altLang="ja-JP" baseline="0" dirty="0">
                <a:solidFill>
                  <a:schemeClr val="tx1"/>
                </a:solidFill>
              </a:rPr>
              <a:t> BMA us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6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upple Figure3 ++'!$K$1</c:f>
              <c:strCache>
                <c:ptCount val="1"/>
                <c:pt idx="0">
                  <c:v>BSI change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626F-42BB-AFD6-9DABD89D0D2B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626F-42BB-AFD6-9DABD89D0D2B}"/>
              </c:ext>
            </c:extLst>
          </c:dPt>
          <c:dPt>
            <c:idx val="2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626F-42BB-AFD6-9DABD89D0D2B}"/>
              </c:ext>
            </c:extLst>
          </c:dPt>
          <c:dPt>
            <c:idx val="3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626F-42BB-AFD6-9DABD89D0D2B}"/>
              </c:ext>
            </c:extLst>
          </c:dPt>
          <c:dPt>
            <c:idx val="4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626F-42BB-AFD6-9DABD89D0D2B}"/>
              </c:ext>
            </c:extLst>
          </c:dPt>
          <c:dPt>
            <c:idx val="5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626F-42BB-AFD6-9DABD89D0D2B}"/>
              </c:ext>
            </c:extLst>
          </c:dPt>
          <c:dPt>
            <c:idx val="6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626F-42BB-AFD6-9DABD89D0D2B}"/>
              </c:ext>
            </c:extLst>
          </c:dPt>
          <c:dPt>
            <c:idx val="7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626F-42BB-AFD6-9DABD89D0D2B}"/>
              </c:ext>
            </c:extLst>
          </c:dPt>
          <c:dPt>
            <c:idx val="8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626F-42BB-AFD6-9DABD89D0D2B}"/>
              </c:ext>
            </c:extLst>
          </c:dPt>
          <c:dPt>
            <c:idx val="9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626F-42BB-AFD6-9DABD89D0D2B}"/>
              </c:ext>
            </c:extLst>
          </c:dPt>
          <c:dPt>
            <c:idx val="1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5-626F-42BB-AFD6-9DABD89D0D2B}"/>
              </c:ext>
            </c:extLst>
          </c:dPt>
          <c:dPt>
            <c:idx val="11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7-626F-42BB-AFD6-9DABD89D0D2B}"/>
              </c:ext>
            </c:extLst>
          </c:dPt>
          <c:dPt>
            <c:idx val="12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9-626F-42BB-AFD6-9DABD89D0D2B}"/>
              </c:ext>
            </c:extLst>
          </c:dPt>
          <c:dPt>
            <c:idx val="13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B-626F-42BB-AFD6-9DABD89D0D2B}"/>
              </c:ext>
            </c:extLst>
          </c:dPt>
          <c:dPt>
            <c:idx val="14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D-626F-42BB-AFD6-9DABD89D0D2B}"/>
              </c:ext>
            </c:extLst>
          </c:dPt>
          <c:dPt>
            <c:idx val="15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F-626F-42BB-AFD6-9DABD89D0D2B}"/>
              </c:ext>
            </c:extLst>
          </c:dPt>
          <c:dPt>
            <c:idx val="16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1-626F-42BB-AFD6-9DABD89D0D2B}"/>
              </c:ext>
            </c:extLst>
          </c:dPt>
          <c:dPt>
            <c:idx val="17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3-626F-42BB-AFD6-9DABD89D0D2B}"/>
              </c:ext>
            </c:extLst>
          </c:dPt>
          <c:dPt>
            <c:idx val="18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5-626F-42BB-AFD6-9DABD89D0D2B}"/>
              </c:ext>
            </c:extLst>
          </c:dPt>
          <c:val>
            <c:numRef>
              <c:f>'supple Figure3 ++'!$K$2:$K$21</c:f>
              <c:numCache>
                <c:formatCode>0.0%</c:formatCode>
                <c:ptCount val="20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-0.11475409836065564</c:v>
                </c:pt>
                <c:pt idx="9">
                  <c:v>-0.23364485981308414</c:v>
                </c:pt>
                <c:pt idx="10">
                  <c:v>-0.3392857142857143</c:v>
                </c:pt>
                <c:pt idx="11">
                  <c:v>-0.36</c:v>
                </c:pt>
                <c:pt idx="12">
                  <c:v>-0.54838709677419351</c:v>
                </c:pt>
                <c:pt idx="13">
                  <c:v>-0.62528216704288941</c:v>
                </c:pt>
                <c:pt idx="14">
                  <c:v>-0.75</c:v>
                </c:pt>
                <c:pt idx="15">
                  <c:v>-0.83333333333333326</c:v>
                </c:pt>
                <c:pt idx="16">
                  <c:v>-1</c:v>
                </c:pt>
                <c:pt idx="17">
                  <c:v>-1</c:v>
                </c:pt>
                <c:pt idx="18">
                  <c:v>-1</c:v>
                </c:pt>
                <c:pt idx="19">
                  <c:v>-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6-626F-42BB-AFD6-9DABD89D0D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6408768"/>
        <c:axId val="346411120"/>
      </c:barChart>
      <c:catAx>
        <c:axId val="346408768"/>
        <c:scaling>
          <c:orientation val="minMax"/>
        </c:scaling>
        <c:delete val="0"/>
        <c:axPos val="b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46411120"/>
        <c:crosses val="autoZero"/>
        <c:auto val="1"/>
        <c:lblAlgn val="ctr"/>
        <c:lblOffset val="100"/>
        <c:noMultiLvlLbl val="0"/>
      </c:catAx>
      <c:valAx>
        <c:axId val="346411120"/>
        <c:scaling>
          <c:orientation val="minMax"/>
          <c:max val="1"/>
          <c:min val="-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464087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9FE9D7A-7BB7-4B33-B644-019739D3A8C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859DA54F-1B3D-4D61-9F1A-E8141F6E1A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2F00D22-AFF2-42FD-B61D-87A8BEE830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23159-2BF9-403D-B077-1E0FB0501340}" type="datetimeFigureOut">
              <a:rPr kumimoji="1" lang="ja-JP" altLang="en-US" smtClean="0"/>
              <a:t>2023/5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C713D1C-86EF-48C1-96F9-162CBBD76C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84CEE7B-AF2F-4268-9932-736863BA41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471BC-DCFB-4304-96B3-087EB2DDC1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00425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C804189-8B80-467E-A116-4D8827DD02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330262B-F689-4A26-BE47-C7B7822AB3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9A58628-7D80-4B4B-B328-AFBE5E701F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23159-2BF9-403D-B077-1E0FB0501340}" type="datetimeFigureOut">
              <a:rPr kumimoji="1" lang="ja-JP" altLang="en-US" smtClean="0"/>
              <a:t>2023/5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F69BE7F-6C7A-4E5F-A5CA-97E0F721F2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449C385-F064-4857-86C0-D006E61805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471BC-DCFB-4304-96B3-087EB2DDC1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22485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D8A96FD-7409-4516-9A58-9925AC00909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0566E2D-624E-49BC-BA2D-8204247A00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E157DE5-66AA-48C8-8C5F-EDDDE0E758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23159-2BF9-403D-B077-1E0FB0501340}" type="datetimeFigureOut">
              <a:rPr kumimoji="1" lang="ja-JP" altLang="en-US" smtClean="0"/>
              <a:t>2023/5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13BD889-381A-44B1-8E1B-FA4D552A4B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4B17F47-EB8A-4A7B-8B6F-697B23E087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471BC-DCFB-4304-96B3-087EB2DDC1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95676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A37014A-020B-4A4E-835B-319A72EE17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A53E64F-4539-4303-892B-469D3397AE9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46792A9-ABED-4A05-8506-71AB3F0D14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23159-2BF9-403D-B077-1E0FB0501340}" type="datetimeFigureOut">
              <a:rPr kumimoji="1" lang="ja-JP" altLang="en-US" smtClean="0"/>
              <a:t>2023/5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12F9B39-A6E9-4F80-89ED-80DBEBDF9E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76BAC11-7692-4110-97D1-F15B76339F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471BC-DCFB-4304-96B3-087EB2DDC1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09870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D3E7893-578D-4499-9E3A-025AA412D5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AB38879-1A7F-4DC4-9ED7-8BD3D7F52E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00C2A41-326D-438C-8982-DFBA126235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23159-2BF9-403D-B077-1E0FB0501340}" type="datetimeFigureOut">
              <a:rPr kumimoji="1" lang="ja-JP" altLang="en-US" smtClean="0"/>
              <a:t>2023/5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17484C4-B243-4079-8D3E-356858E6B1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64821F4-C896-47EC-9C88-8C2B3A66E2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471BC-DCFB-4304-96B3-087EB2DDC1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14019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F39CDAA-D7E2-41B5-B49F-3D0E38220D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E33CC74-918C-4004-8FFD-B031FEB85EE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2135A3F-9989-4EC9-948F-A0A4437F7E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EEB634C-A826-487E-A4B4-1843C63E51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23159-2BF9-403D-B077-1E0FB0501340}" type="datetimeFigureOut">
              <a:rPr kumimoji="1" lang="ja-JP" altLang="en-US" smtClean="0"/>
              <a:t>2023/5/2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7330683-C697-4967-8FBD-064F9E3CB6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E7FA126-9403-4E16-92D1-51635B3C8B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471BC-DCFB-4304-96B3-087EB2DDC1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81567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3B6BC1E-A303-47E1-9713-C6C448837B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E3AD3B1-9202-4CBB-B665-5E84B14DE4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E122F54-C7B6-4E57-8AFB-3182172EF2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B338F84F-5D6B-4B92-95B8-78190B567D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055871D7-FF42-4E30-91AE-1331D5C7F17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7089A046-9031-4A93-98AE-D7012E76D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23159-2BF9-403D-B077-1E0FB0501340}" type="datetimeFigureOut">
              <a:rPr kumimoji="1" lang="ja-JP" altLang="en-US" smtClean="0"/>
              <a:t>2023/5/2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AB32581-6571-48F4-AA86-F8C873F26E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B23FBF26-92A5-4BFC-A81A-62484A8BDB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471BC-DCFB-4304-96B3-087EB2DDC1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7619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FB0123B-ECEE-49ED-BCCC-E3154DA305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0F49AC0F-2268-40DB-AD23-91DF207EE5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23159-2BF9-403D-B077-1E0FB0501340}" type="datetimeFigureOut">
              <a:rPr kumimoji="1" lang="ja-JP" altLang="en-US" smtClean="0"/>
              <a:t>2023/5/2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6D48DEEF-EC3B-42B6-B412-0F4B640D5E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D6F33491-93DC-4F89-94B5-5B9AB780A0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471BC-DCFB-4304-96B3-087EB2DDC1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88248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E9D2335-2DCC-4D94-9C1B-EAB8F5F311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23159-2BF9-403D-B077-1E0FB0501340}" type="datetimeFigureOut">
              <a:rPr kumimoji="1" lang="ja-JP" altLang="en-US" smtClean="0"/>
              <a:t>2023/5/2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4842860-1238-4BF3-BFAC-5AFD3A0DF6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5E03DB3-B7A7-4246-A378-9A8F6EC91D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471BC-DCFB-4304-96B3-087EB2DDC1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91555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02A50DE-5544-48AB-A3E7-9F9317DC83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CD39CBE-7523-4695-983C-269802577D5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90F9D03-FE72-4BEF-925D-80410B2643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17D7AF4-7638-48BC-A101-2CD98A6F5B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23159-2BF9-403D-B077-1E0FB0501340}" type="datetimeFigureOut">
              <a:rPr kumimoji="1" lang="ja-JP" altLang="en-US" smtClean="0"/>
              <a:t>2023/5/2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F45E925-FBD8-4E38-BD3B-5F0A5EC0C8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E2090A1-0B69-4F96-9F46-6D834F569C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471BC-DCFB-4304-96B3-087EB2DDC1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54723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C196B87-2AD3-4E1C-BA37-917A83714E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FFCDBE5-AD6E-48D9-AEDD-688323D4619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97BCD23-5D99-4552-88B9-E6A5AA8C95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AA9CDC1-B93D-4455-B478-2E8B909741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023159-2BF9-403D-B077-1E0FB0501340}" type="datetimeFigureOut">
              <a:rPr kumimoji="1" lang="ja-JP" altLang="en-US" smtClean="0"/>
              <a:t>2023/5/2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3D45A78-0BD6-4AC4-A6DC-A63EBA48D4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47A73A3-7146-4E56-B16A-88B2DBE7FF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471BC-DCFB-4304-96B3-087EB2DDC1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2263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4A538EA-E8B7-4025-A61A-0494FA8EF3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05C9045-F503-48D1-BE0D-12A15F022F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97E0643-D578-4BEF-B1C0-CA43D040119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023159-2BF9-403D-B077-1E0FB0501340}" type="datetimeFigureOut">
              <a:rPr kumimoji="1" lang="ja-JP" altLang="en-US" smtClean="0"/>
              <a:t>2023/5/2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767F7CB-BE00-4D45-BF76-BF4CF30DE7E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FAD9C81-1D80-4470-A242-319303CED0B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2471BC-DCFB-4304-96B3-087EB2DDC1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1643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C31239D-DCA7-06CF-AA16-DC0BB848A7A7}"/>
              </a:ext>
            </a:extLst>
          </p:cNvPr>
          <p:cNvSpPr txBox="1"/>
          <p:nvPr/>
        </p:nvSpPr>
        <p:spPr>
          <a:xfrm>
            <a:off x="400125" y="453310"/>
            <a:ext cx="1095691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</a:t>
            </a:r>
            <a:endParaRPr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SI and PSA reduction rates in patients with visceral metastasis treated with enzalutamide (waterfall plots)</a:t>
            </a:r>
            <a:endParaRPr lang="ja-JP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840CC24-E5A1-7617-5529-D2CF1ECCC8E0}"/>
              </a:ext>
            </a:extLst>
          </p:cNvPr>
          <p:cNvSpPr txBox="1"/>
          <p:nvPr/>
        </p:nvSpPr>
        <p:spPr>
          <a:xfrm>
            <a:off x="918287" y="5573693"/>
            <a:ext cx="992058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kern="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1a. </a:t>
            </a:r>
            <a:r>
              <a:rPr lang="en-US" altLang="ja-JP" sz="12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BSI reduction was defined as a decrease in BSI </a:t>
            </a:r>
            <a:r>
              <a:rPr lang="en-GB" altLang="ja-JP" sz="12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t the end of the observation period </a:t>
            </a:r>
            <a:r>
              <a:rPr lang="en-US" altLang="ja-JP" sz="12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ompared to baseline </a:t>
            </a:r>
            <a:r>
              <a:rPr lang="en-GB" altLang="ja-JP" sz="12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s best BSI change while on ENZ treatment</a:t>
            </a:r>
            <a:r>
              <a:rPr lang="en-US" altLang="ja-JP" sz="12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BSI reduction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as observed in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% (12/15 patients). </a:t>
            </a:r>
            <a:r>
              <a:rPr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b.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PSA reduction rate was evaluated at 3 months after enzalutamide administration. PSA decreased by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87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% (13/15 patients).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SI, bone scan index</a:t>
            </a:r>
            <a:r>
              <a:rPr lang="en-GB" altLang="ja-JP" sz="12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; PSA, prostate-specific antigen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DAC6DEBF-7884-ABE2-1789-8817FF9CE3C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17116206"/>
              </p:ext>
            </p:extLst>
          </p:nvPr>
        </p:nvGraphicFramePr>
        <p:xfrm>
          <a:off x="997777" y="1678796"/>
          <a:ext cx="4413671" cy="32298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655F4A56-04FE-EC31-30E5-75F16D9CA8E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18102387"/>
              </p:ext>
            </p:extLst>
          </p:nvPr>
        </p:nvGraphicFramePr>
        <p:xfrm>
          <a:off x="6096000" y="1678796"/>
          <a:ext cx="4487350" cy="32169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933D3F1-3B69-F9C7-EDFF-35A1A17BF290}"/>
              </a:ext>
            </a:extLst>
          </p:cNvPr>
          <p:cNvSpPr txBox="1"/>
          <p:nvPr/>
        </p:nvSpPr>
        <p:spPr>
          <a:xfrm>
            <a:off x="313225" y="1309464"/>
            <a:ext cx="5004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a.</a:t>
            </a:r>
            <a:endParaRPr kumimoji="1" lang="ja-JP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7E5C823-65A7-CF6C-E2E5-9BCB73EC2F1E}"/>
              </a:ext>
            </a:extLst>
          </p:cNvPr>
          <p:cNvSpPr txBox="1"/>
          <p:nvPr/>
        </p:nvSpPr>
        <p:spPr>
          <a:xfrm>
            <a:off x="5845771" y="1309464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b.</a:t>
            </a:r>
            <a:endParaRPr kumimoji="1" lang="ja-JP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71573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C31239D-DCA7-06CF-AA16-DC0BB848A7A7}"/>
              </a:ext>
            </a:extLst>
          </p:cNvPr>
          <p:cNvSpPr txBox="1"/>
          <p:nvPr/>
        </p:nvSpPr>
        <p:spPr>
          <a:xfrm>
            <a:off x="278205" y="592647"/>
            <a:ext cx="1135445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</a:t>
            </a:r>
            <a:endParaRPr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SI and PSA reduction rates in patients treated with docetaxel before enzalutamide treatment (waterfall plots)</a:t>
            </a:r>
            <a:endParaRPr lang="ja-JP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870BF51-CB86-A2B9-08C3-3047484E221C}"/>
              </a:ext>
            </a:extLst>
          </p:cNvPr>
          <p:cNvSpPr txBox="1"/>
          <p:nvPr/>
        </p:nvSpPr>
        <p:spPr>
          <a:xfrm>
            <a:off x="862149" y="5543995"/>
            <a:ext cx="992058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a.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SI reduction was defined as a decrease in BSI </a:t>
            </a:r>
            <a:r>
              <a:rPr lang="en-GB" altLang="ja-JP" sz="12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t the end of the observation period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ompared to baseline </a:t>
            </a:r>
            <a:r>
              <a:rPr lang="en-GB" altLang="ja-JP" sz="12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s best BSI change while </a:t>
            </a:r>
            <a:r>
              <a:rPr lang="en-GB" altLang="ja-JP" sz="1200" kern="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n</a:t>
            </a:r>
            <a:r>
              <a:rPr lang="en-GB" altLang="ja-JP" sz="12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ENZ treatment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. BSI reduction was observed in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62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% (13/21 patients). </a:t>
            </a:r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b.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PSA reduction rate was evaluated 3 months after enzalutamide administration. PSA decreased by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71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%(15/21 patients). </a:t>
            </a:r>
            <a:r>
              <a:rPr lang="ja-JP" altLang="ja-JP" sz="1200" kern="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The mean follow-up period for ENZ treatment in the post-docetaxel group was 14.5 months, and the median PFS was 9.5 (</a:t>
            </a:r>
            <a:r>
              <a:rPr lang="en-US" altLang="ja-JP" sz="1200" kern="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2.5–20.0</a:t>
            </a:r>
            <a:r>
              <a:rPr lang="ja-JP" altLang="ja-JP" sz="1200" kern="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) months.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SI, bone scan index</a:t>
            </a:r>
            <a:r>
              <a:rPr lang="en-GB" altLang="ja-JP" sz="12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; PSA, prostate-specific antigen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50AB87C2-EA34-B1E1-4614-DA496771990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82929315"/>
              </p:ext>
            </p:extLst>
          </p:nvPr>
        </p:nvGraphicFramePr>
        <p:xfrm>
          <a:off x="862148" y="1663908"/>
          <a:ext cx="5233851" cy="33766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71022317-F25F-C61D-AE09-E31BA24C4A7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61405974"/>
              </p:ext>
            </p:extLst>
          </p:nvPr>
        </p:nvGraphicFramePr>
        <p:xfrm>
          <a:off x="6388153" y="1657735"/>
          <a:ext cx="5234364" cy="34423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F2233D6-7C75-11D0-E0E8-2EFAA449FCE7}"/>
              </a:ext>
            </a:extLst>
          </p:cNvPr>
          <p:cNvSpPr txBox="1"/>
          <p:nvPr/>
        </p:nvSpPr>
        <p:spPr>
          <a:xfrm>
            <a:off x="313225" y="1309464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a.</a:t>
            </a:r>
            <a:endParaRPr kumimoji="1" lang="ja-JP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FF28914-F5E8-0375-5E17-F92764A65CFD}"/>
              </a:ext>
            </a:extLst>
          </p:cNvPr>
          <p:cNvSpPr txBox="1"/>
          <p:nvPr/>
        </p:nvSpPr>
        <p:spPr>
          <a:xfrm>
            <a:off x="5845771" y="1309464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kumimoji="1" lang="ja-JP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486806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C31239D-DCA7-06CF-AA16-DC0BB848A7A7}"/>
              </a:ext>
            </a:extLst>
          </p:cNvPr>
          <p:cNvSpPr txBox="1"/>
          <p:nvPr/>
        </p:nvSpPr>
        <p:spPr>
          <a:xfrm>
            <a:off x="609131" y="462018"/>
            <a:ext cx="109568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Figure 3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SI reduction rates for patients with and without use of bone-modifying agents at baseline (waterfall plots).</a:t>
            </a:r>
            <a:endParaRPr kumimoji="1" lang="ja-JP" altLang="ja-JP" sz="18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0219A6F-C3FC-A8DE-7F99-AA401825769C}"/>
              </a:ext>
            </a:extLst>
          </p:cNvPr>
          <p:cNvSpPr txBox="1"/>
          <p:nvPr/>
        </p:nvSpPr>
        <p:spPr>
          <a:xfrm>
            <a:off x="862149" y="5543995"/>
            <a:ext cx="992058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GB" altLang="ja-JP" sz="120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+mn-cs"/>
              </a:rPr>
              <a:t>BSI reduction was defined as a decrease in BSI at the end of the observation period compared to baseline as best BSI change while on ENZ treatment. BSI reduction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was observed in 69% (48/70 patients) with use of BMAs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(3a)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, and 60% (12/20 patients) without the use of BMAs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(3b)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SI, bone scan index; BMAs, bone-modifying agents 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AEB69C17-7FCC-4F52-B2DA-D7610124B78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22487425"/>
              </p:ext>
            </p:extLst>
          </p:nvPr>
        </p:nvGraphicFramePr>
        <p:xfrm>
          <a:off x="862149" y="1897771"/>
          <a:ext cx="5987546" cy="27364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3A550A4F-3948-98F7-3744-8B1B1A82273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6642839"/>
              </p:ext>
            </p:extLst>
          </p:nvPr>
        </p:nvGraphicFramePr>
        <p:xfrm>
          <a:off x="7240378" y="1886380"/>
          <a:ext cx="4089473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D6BD16A-474F-CF13-6938-B896E126EA35}"/>
              </a:ext>
            </a:extLst>
          </p:cNvPr>
          <p:cNvSpPr txBox="1"/>
          <p:nvPr/>
        </p:nvSpPr>
        <p:spPr>
          <a:xfrm>
            <a:off x="922828" y="1309464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kumimoji="1" lang="ja-JP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A6429F4-FEA1-6A8D-C731-A3C2AB393AC6}"/>
              </a:ext>
            </a:extLst>
          </p:cNvPr>
          <p:cNvSpPr txBox="1"/>
          <p:nvPr/>
        </p:nvSpPr>
        <p:spPr>
          <a:xfrm>
            <a:off x="7005078" y="1309464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b.</a:t>
            </a:r>
            <a:endParaRPr kumimoji="1" lang="ja-JP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13159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游ゴシック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游ゴシック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游ゴシック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游ゴシック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游ゴシック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游ゴシック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游ゴシック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游ゴシック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游ゴシック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游ゴシック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游ゴシック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游ゴシック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6332</TotalTime>
  <Words>368</Words>
  <Application>Microsoft Office PowerPoint</Application>
  <PresentationFormat>ワイド画面</PresentationFormat>
  <Paragraphs>24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7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政義 永田</dc:creator>
  <cp:lastModifiedBy>永田 政義</cp:lastModifiedBy>
  <cp:revision>123</cp:revision>
  <cp:lastPrinted>2023-04-27T08:59:52Z</cp:lastPrinted>
  <dcterms:created xsi:type="dcterms:W3CDTF">2020-11-22T13:38:21Z</dcterms:created>
  <dcterms:modified xsi:type="dcterms:W3CDTF">2023-05-25T05:17:10Z</dcterms:modified>
</cp:coreProperties>
</file>